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zh-TW"/>
    </a:defPPr>
    <a:lvl1pPr marL="0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399974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799947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199921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599894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1999867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399842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799815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199788" algn="l" defTabSz="79994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762" autoAdjust="0"/>
  </p:normalViewPr>
  <p:slideViewPr>
    <p:cSldViewPr>
      <p:cViewPr>
        <p:scale>
          <a:sx n="152" d="100"/>
          <a:sy n="152" d="100"/>
        </p:scale>
        <p:origin x="-248" y="3272"/>
      </p:cViewPr>
      <p:guideLst>
        <p:guide orient="horz" pos="2019"/>
        <p:guide pos="22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HD:Research:SlSERK3AB%20PAPER:Lastest%20version:SlSERK3s%20All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HD:Research:SlSERK3AB%20PAPER:Lastest%20version:20100702ROOT%20SlSERK-VIGS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7394268392831"/>
          <c:y val="0.0361111111111111"/>
          <c:w val="0.809024926332061"/>
          <c:h val="0.8125940507436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110526Nema SUS'!$O$6:$O$8</c:f>
                <c:numCache>
                  <c:formatCode>General</c:formatCode>
                  <c:ptCount val="3"/>
                  <c:pt idx="0">
                    <c:v>5.570683680363353</c:v>
                  </c:pt>
                  <c:pt idx="1">
                    <c:v>9.144275683605402</c:v>
                  </c:pt>
                  <c:pt idx="2">
                    <c:v>6.171509609827854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strRef>
              <c:f>'20110526Nema SUS'!$M$6:$M$8</c:f>
              <c:strCache>
                <c:ptCount val="3"/>
                <c:pt idx="0">
                  <c:v>TRV</c:v>
                </c:pt>
                <c:pt idx="1">
                  <c:v>TRV-SERK3A</c:v>
                </c:pt>
                <c:pt idx="2">
                  <c:v>TRV-SERK3B</c:v>
                </c:pt>
              </c:strCache>
            </c:strRef>
          </c:cat>
          <c:val>
            <c:numRef>
              <c:f>'20110526Nema SUS'!$N$6:$N$8</c:f>
              <c:numCache>
                <c:formatCode>General</c:formatCode>
                <c:ptCount val="3"/>
                <c:pt idx="0">
                  <c:v>62.60333333333334</c:v>
                </c:pt>
                <c:pt idx="1">
                  <c:v>51.6</c:v>
                </c:pt>
                <c:pt idx="2">
                  <c:v>58.944444444444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1622360"/>
        <c:axId val="2127056008"/>
      </c:barChart>
      <c:catAx>
        <c:axId val="206162236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2127056008"/>
        <c:crosses val="autoZero"/>
        <c:auto val="1"/>
        <c:lblAlgn val="ctr"/>
        <c:lblOffset val="100"/>
        <c:noMultiLvlLbl val="0"/>
      </c:catAx>
      <c:valAx>
        <c:axId val="212705600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 Weight </a:t>
                </a:r>
                <a:r>
                  <a:rPr lang="en-US" b="0" dirty="0" smtClean="0"/>
                  <a:t>per </a:t>
                </a:r>
                <a:r>
                  <a:rPr lang="en-US" b="0" dirty="0"/>
                  <a:t>root (g)</a:t>
                </a:r>
              </a:p>
            </c:rich>
          </c:tx>
          <c:layout>
            <c:manualLayout>
              <c:xMode val="edge"/>
              <c:yMode val="edge"/>
              <c:x val="0.0"/>
              <c:y val="0.2902081510644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20616223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2546140065825"/>
          <c:y val="0.0361111111111111"/>
          <c:w val="0.833873057534475"/>
          <c:h val="0.7061124234470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100702ROOT SlSERKs-VIGS'!$N$122</c:f>
              <c:strCache>
                <c:ptCount val="1"/>
                <c:pt idx="0">
                  <c:v>SlSERK3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100702ROOT SlSERKs-VIGS'!$Q$123:$Q$135</c:f>
                <c:numCache>
                  <c:formatCode>General</c:formatCode>
                  <c:ptCount val="13"/>
                  <c:pt idx="0">
                    <c:v>0.0693702354997427</c:v>
                  </c:pt>
                  <c:pt idx="1">
                    <c:v>0.0192427738951679</c:v>
                  </c:pt>
                  <c:pt idx="2">
                    <c:v>0.0396825981080435</c:v>
                  </c:pt>
                  <c:pt idx="3">
                    <c:v>0.297030887766288</c:v>
                  </c:pt>
                  <c:pt idx="4">
                    <c:v>0.0412230291739411</c:v>
                  </c:pt>
                  <c:pt idx="5">
                    <c:v>0.0480534741659428</c:v>
                  </c:pt>
                  <c:pt idx="6">
                    <c:v>0.0456965258340572</c:v>
                  </c:pt>
                  <c:pt idx="7">
                    <c:v>0.0583331823570395</c:v>
                  </c:pt>
                  <c:pt idx="8">
                    <c:v>0.0334835042315959</c:v>
                  </c:pt>
                  <c:pt idx="9">
                    <c:v>0.0583331823570395</c:v>
                  </c:pt>
                  <c:pt idx="10">
                    <c:v>0.0693702354997425</c:v>
                  </c:pt>
                  <c:pt idx="11">
                    <c:v>0.156957589640547</c:v>
                  </c:pt>
                  <c:pt idx="12">
                    <c:v>0.0461967273626116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strRef>
              <c:f>'20100702ROOT SlSERKs-VIGS'!$M$123:$M$135</c:f>
              <c:strCache>
                <c:ptCount val="13"/>
                <c:pt idx="0">
                  <c:v>TRV</c:v>
                </c:pt>
                <c:pt idx="1">
                  <c:v>SERK3A-1</c:v>
                </c:pt>
                <c:pt idx="2">
                  <c:v>SERK3A-2</c:v>
                </c:pt>
                <c:pt idx="3">
                  <c:v>SERK3A-3</c:v>
                </c:pt>
                <c:pt idx="4">
                  <c:v>SERK3A-4</c:v>
                </c:pt>
                <c:pt idx="5">
                  <c:v>SERK3A-5</c:v>
                </c:pt>
                <c:pt idx="6">
                  <c:v>SERK3A-6</c:v>
                </c:pt>
                <c:pt idx="7">
                  <c:v>SERK3B-1</c:v>
                </c:pt>
                <c:pt idx="8">
                  <c:v>SERK3B-2</c:v>
                </c:pt>
                <c:pt idx="9">
                  <c:v>SERK3B-3</c:v>
                </c:pt>
                <c:pt idx="10">
                  <c:v>SERK3B-4</c:v>
                </c:pt>
                <c:pt idx="11">
                  <c:v>SERK3B-5</c:v>
                </c:pt>
                <c:pt idx="12">
                  <c:v>SERK3B-6</c:v>
                </c:pt>
              </c:strCache>
            </c:strRef>
          </c:cat>
          <c:val>
            <c:numRef>
              <c:f>'20100702ROOT SlSERKs-VIGS'!$N$123:$N$135</c:f>
              <c:numCache>
                <c:formatCode>General</c:formatCode>
                <c:ptCount val="13"/>
                <c:pt idx="0">
                  <c:v>1.002403227036551</c:v>
                </c:pt>
                <c:pt idx="1">
                  <c:v>0.278059004855512</c:v>
                </c:pt>
                <c:pt idx="2">
                  <c:v>0.193575649776158</c:v>
                </c:pt>
                <c:pt idx="3">
                  <c:v>0.297572669735072</c:v>
                </c:pt>
                <c:pt idx="4">
                  <c:v>1.189921384170975</c:v>
                </c:pt>
                <c:pt idx="5">
                  <c:v>0.201946525834057</c:v>
                </c:pt>
                <c:pt idx="6">
                  <c:v>0.108196525834057</c:v>
                </c:pt>
                <c:pt idx="7">
                  <c:v>0.842917280253789</c:v>
                </c:pt>
                <c:pt idx="8">
                  <c:v>0.966516495768404</c:v>
                </c:pt>
                <c:pt idx="9">
                  <c:v>0.842917280253789</c:v>
                </c:pt>
                <c:pt idx="10">
                  <c:v>1.002403227036548</c:v>
                </c:pt>
                <c:pt idx="11">
                  <c:v>0.914815872895746</c:v>
                </c:pt>
                <c:pt idx="12">
                  <c:v>1.219825556881316</c:v>
                </c:pt>
              </c:numCache>
            </c:numRef>
          </c:val>
        </c:ser>
        <c:ser>
          <c:idx val="1"/>
          <c:order val="1"/>
          <c:tx>
            <c:strRef>
              <c:f>'20100702ROOT SlSERKs-VIGS'!$O$122</c:f>
              <c:strCache>
                <c:ptCount val="1"/>
                <c:pt idx="0">
                  <c:v>SlSERK3B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100702ROOT SlSERKs-VIGS'!$R$123:$R$135</c:f>
                <c:numCache>
                  <c:formatCode>General</c:formatCode>
                  <c:ptCount val="13"/>
                  <c:pt idx="0">
                    <c:v>0.0693702354997427</c:v>
                  </c:pt>
                  <c:pt idx="1">
                    <c:v>0.032342933157008</c:v>
                  </c:pt>
                  <c:pt idx="2">
                    <c:v>0.121070858372401</c:v>
                  </c:pt>
                  <c:pt idx="3">
                    <c:v>0.0769710955806715</c:v>
                  </c:pt>
                  <c:pt idx="4">
                    <c:v>0.0938738018218838</c:v>
                  </c:pt>
                  <c:pt idx="5">
                    <c:v>0.182333340674874</c:v>
                  </c:pt>
                  <c:pt idx="6">
                    <c:v>0.0875873541408049</c:v>
                  </c:pt>
                  <c:pt idx="7">
                    <c:v>0.00947568987089265</c:v>
                  </c:pt>
                  <c:pt idx="8">
                    <c:v>0.0355715191456855</c:v>
                  </c:pt>
                  <c:pt idx="9">
                    <c:v>0.0279088482597339</c:v>
                  </c:pt>
                  <c:pt idx="10">
                    <c:v>0.0647247183519379</c:v>
                  </c:pt>
                  <c:pt idx="11">
                    <c:v>0.0580141585914816</c:v>
                  </c:pt>
                  <c:pt idx="12">
                    <c:v>0.0302677145931003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strRef>
              <c:f>'20100702ROOT SlSERKs-VIGS'!$M$123:$M$135</c:f>
              <c:strCache>
                <c:ptCount val="13"/>
                <c:pt idx="0">
                  <c:v>TRV</c:v>
                </c:pt>
                <c:pt idx="1">
                  <c:v>SERK3A-1</c:v>
                </c:pt>
                <c:pt idx="2">
                  <c:v>SERK3A-2</c:v>
                </c:pt>
                <c:pt idx="3">
                  <c:v>SERK3A-3</c:v>
                </c:pt>
                <c:pt idx="4">
                  <c:v>SERK3A-4</c:v>
                </c:pt>
                <c:pt idx="5">
                  <c:v>SERK3A-5</c:v>
                </c:pt>
                <c:pt idx="6">
                  <c:v>SERK3A-6</c:v>
                </c:pt>
                <c:pt idx="7">
                  <c:v>SERK3B-1</c:v>
                </c:pt>
                <c:pt idx="8">
                  <c:v>SERK3B-2</c:v>
                </c:pt>
                <c:pt idx="9">
                  <c:v>SERK3B-3</c:v>
                </c:pt>
                <c:pt idx="10">
                  <c:v>SERK3B-4</c:v>
                </c:pt>
                <c:pt idx="11">
                  <c:v>SERK3B-5</c:v>
                </c:pt>
                <c:pt idx="12">
                  <c:v>SERK3B-6</c:v>
                </c:pt>
              </c:strCache>
            </c:strRef>
          </c:cat>
          <c:val>
            <c:numRef>
              <c:f>'20100702ROOT SlSERKs-VIGS'!$O$123:$O$135</c:f>
              <c:numCache>
                <c:formatCode>General</c:formatCode>
                <c:ptCount val="13"/>
                <c:pt idx="0">
                  <c:v>1.002403227036551</c:v>
                </c:pt>
                <c:pt idx="1">
                  <c:v>0.933593395767836</c:v>
                </c:pt>
                <c:pt idx="2">
                  <c:v>0.878929141627599</c:v>
                </c:pt>
                <c:pt idx="3">
                  <c:v>1.11223601942205</c:v>
                </c:pt>
                <c:pt idx="4">
                  <c:v>0.906126198178117</c:v>
                </c:pt>
                <c:pt idx="5">
                  <c:v>0.889440121861422</c:v>
                </c:pt>
                <c:pt idx="6">
                  <c:v>0.845445637396003</c:v>
                </c:pt>
                <c:pt idx="7">
                  <c:v>0.0552283678691934</c:v>
                </c:pt>
                <c:pt idx="8">
                  <c:v>0.343357622481915</c:v>
                </c:pt>
                <c:pt idx="9">
                  <c:v>0.269392930490945</c:v>
                </c:pt>
                <c:pt idx="10">
                  <c:v>0.935275281648062</c:v>
                </c:pt>
                <c:pt idx="11">
                  <c:v>0.191985841408519</c:v>
                </c:pt>
                <c:pt idx="12">
                  <c:v>0.21973228540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5715368"/>
        <c:axId val="-2145726968"/>
      </c:barChart>
      <c:catAx>
        <c:axId val="-21457153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-2145726968"/>
        <c:crosses val="autoZero"/>
        <c:auto val="1"/>
        <c:lblAlgn val="ctr"/>
        <c:lblOffset val="100"/>
        <c:noMultiLvlLbl val="0"/>
      </c:catAx>
      <c:valAx>
        <c:axId val="-21457269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amount</a:t>
                </a:r>
              </a:p>
            </c:rich>
          </c:tx>
          <c:layout>
            <c:manualLayout>
              <c:xMode val="edge"/>
              <c:yMode val="edge"/>
              <c:x val="0.0148689747114944"/>
              <c:y val="0.3133562992125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-21457153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8964817113718"/>
          <c:y val="0.00243219597550306"/>
          <c:w val="0.250270778652668"/>
          <c:h val="0.167357611548556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7"/>
            <a:ext cx="5829300" cy="1960034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99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999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999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998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998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998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998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997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4"/>
            <a:ext cx="1543050" cy="7802033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4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50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9997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9994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999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9989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9986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9984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9981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9978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9974" indent="0">
              <a:buNone/>
              <a:defRPr sz="1700" b="1"/>
            </a:lvl2pPr>
            <a:lvl3pPr marL="799947" indent="0">
              <a:buNone/>
              <a:defRPr sz="1600" b="1"/>
            </a:lvl3pPr>
            <a:lvl4pPr marL="1199921" indent="0">
              <a:buNone/>
              <a:defRPr sz="1400" b="1"/>
            </a:lvl4pPr>
            <a:lvl5pPr marL="1599894" indent="0">
              <a:buNone/>
              <a:defRPr sz="1400" b="1"/>
            </a:lvl5pPr>
            <a:lvl6pPr marL="1999867" indent="0">
              <a:buNone/>
              <a:defRPr sz="1400" b="1"/>
            </a:lvl6pPr>
            <a:lvl7pPr marL="2399842" indent="0">
              <a:buNone/>
              <a:defRPr sz="1400" b="1"/>
            </a:lvl7pPr>
            <a:lvl8pPr marL="2799815" indent="0">
              <a:buNone/>
              <a:defRPr sz="1400" b="1"/>
            </a:lvl8pPr>
            <a:lvl9pPr marL="3199788" indent="0">
              <a:buNone/>
              <a:defRPr sz="14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1" y="2899835"/>
            <a:ext cx="3030141" cy="5268384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9974" indent="0">
              <a:buNone/>
              <a:defRPr sz="1700" b="1"/>
            </a:lvl2pPr>
            <a:lvl3pPr marL="799947" indent="0">
              <a:buNone/>
              <a:defRPr sz="1600" b="1"/>
            </a:lvl3pPr>
            <a:lvl4pPr marL="1199921" indent="0">
              <a:buNone/>
              <a:defRPr sz="1400" b="1"/>
            </a:lvl4pPr>
            <a:lvl5pPr marL="1599894" indent="0">
              <a:buNone/>
              <a:defRPr sz="1400" b="1"/>
            </a:lvl5pPr>
            <a:lvl6pPr marL="1999867" indent="0">
              <a:buNone/>
              <a:defRPr sz="1400" b="1"/>
            </a:lvl6pPr>
            <a:lvl7pPr marL="2399842" indent="0">
              <a:buNone/>
              <a:defRPr sz="1400" b="1"/>
            </a:lvl7pPr>
            <a:lvl8pPr marL="2799815" indent="0">
              <a:buNone/>
              <a:defRPr sz="1400" b="1"/>
            </a:lvl8pPr>
            <a:lvl9pPr marL="3199788" indent="0">
              <a:buNone/>
              <a:defRPr sz="14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71" y="2899835"/>
            <a:ext cx="3031331" cy="5268384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2" y="1913469"/>
            <a:ext cx="2256235" cy="6254751"/>
          </a:xfrm>
        </p:spPr>
        <p:txBody>
          <a:bodyPr/>
          <a:lstStyle>
            <a:lvl1pPr marL="0" indent="0">
              <a:buNone/>
              <a:defRPr sz="1200"/>
            </a:lvl1pPr>
            <a:lvl2pPr marL="399974" indent="0">
              <a:buNone/>
              <a:defRPr sz="1000"/>
            </a:lvl2pPr>
            <a:lvl3pPr marL="799947" indent="0">
              <a:buNone/>
              <a:defRPr sz="900"/>
            </a:lvl3pPr>
            <a:lvl4pPr marL="1199921" indent="0">
              <a:buNone/>
              <a:defRPr sz="800"/>
            </a:lvl4pPr>
            <a:lvl5pPr marL="1599894" indent="0">
              <a:buNone/>
              <a:defRPr sz="800"/>
            </a:lvl5pPr>
            <a:lvl6pPr marL="1999867" indent="0">
              <a:buNone/>
              <a:defRPr sz="800"/>
            </a:lvl6pPr>
            <a:lvl7pPr marL="2399842" indent="0">
              <a:buNone/>
              <a:defRPr sz="800"/>
            </a:lvl7pPr>
            <a:lvl8pPr marL="2799815" indent="0">
              <a:buNone/>
              <a:defRPr sz="800"/>
            </a:lvl8pPr>
            <a:lvl9pPr marL="3199788" indent="0">
              <a:buNone/>
              <a:defRPr sz="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5"/>
            <a:ext cx="4114800" cy="5486400"/>
          </a:xfrm>
        </p:spPr>
        <p:txBody>
          <a:bodyPr/>
          <a:lstStyle>
            <a:lvl1pPr marL="0" indent="0">
              <a:buNone/>
              <a:defRPr sz="2800"/>
            </a:lvl1pPr>
            <a:lvl2pPr marL="399974" indent="0">
              <a:buNone/>
              <a:defRPr sz="2400"/>
            </a:lvl2pPr>
            <a:lvl3pPr marL="799947" indent="0">
              <a:buNone/>
              <a:defRPr sz="2100"/>
            </a:lvl3pPr>
            <a:lvl4pPr marL="1199921" indent="0">
              <a:buNone/>
              <a:defRPr sz="1700"/>
            </a:lvl4pPr>
            <a:lvl5pPr marL="1599894" indent="0">
              <a:buNone/>
              <a:defRPr sz="1700"/>
            </a:lvl5pPr>
            <a:lvl6pPr marL="1999867" indent="0">
              <a:buNone/>
              <a:defRPr sz="1700"/>
            </a:lvl6pPr>
            <a:lvl7pPr marL="2399842" indent="0">
              <a:buNone/>
              <a:defRPr sz="1700"/>
            </a:lvl7pPr>
            <a:lvl8pPr marL="2799815" indent="0">
              <a:buNone/>
              <a:defRPr sz="1700"/>
            </a:lvl8pPr>
            <a:lvl9pPr marL="3199788" indent="0">
              <a:buNone/>
              <a:defRPr sz="17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0"/>
            <a:ext cx="4114800" cy="1073150"/>
          </a:xfrm>
        </p:spPr>
        <p:txBody>
          <a:bodyPr/>
          <a:lstStyle>
            <a:lvl1pPr marL="0" indent="0">
              <a:buNone/>
              <a:defRPr sz="1200"/>
            </a:lvl1pPr>
            <a:lvl2pPr marL="399974" indent="0">
              <a:buNone/>
              <a:defRPr sz="1000"/>
            </a:lvl2pPr>
            <a:lvl3pPr marL="799947" indent="0">
              <a:buNone/>
              <a:defRPr sz="900"/>
            </a:lvl3pPr>
            <a:lvl4pPr marL="1199921" indent="0">
              <a:buNone/>
              <a:defRPr sz="800"/>
            </a:lvl4pPr>
            <a:lvl5pPr marL="1599894" indent="0">
              <a:buNone/>
              <a:defRPr sz="800"/>
            </a:lvl5pPr>
            <a:lvl6pPr marL="1999867" indent="0">
              <a:buNone/>
              <a:defRPr sz="800"/>
            </a:lvl6pPr>
            <a:lvl7pPr marL="2399842" indent="0">
              <a:buNone/>
              <a:defRPr sz="800"/>
            </a:lvl7pPr>
            <a:lvl8pPr marL="2799815" indent="0">
              <a:buNone/>
              <a:defRPr sz="800"/>
            </a:lvl8pPr>
            <a:lvl9pPr marL="3199788" indent="0">
              <a:buNone/>
              <a:defRPr sz="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79995" tIns="39997" rIns="79995" bIns="39997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79995" tIns="39997" rIns="79995" bIns="39997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79995" tIns="39997" rIns="79995" bIns="39997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09F13B-B917-4563-BC07-20CA07C71845}" type="datetimeFigureOut">
              <a:rPr lang="zh-TW" altLang="en-US" smtClean="0"/>
              <a:t>1/2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79995" tIns="39997" rIns="79995" bIns="39997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79995" tIns="39997" rIns="79995" bIns="39997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8758C-6C69-4B01-A2FE-6FECF42D4AA7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99947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80" indent="-299980" algn="l" defTabSz="799947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49957" indent="-249983" algn="l" defTabSz="799947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99935" indent="-199986" algn="l" defTabSz="799947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99907" indent="-199986" algn="l" defTabSz="799947" rtl="0" eaLnBrk="1" latinLnBrk="0" hangingPunct="1">
        <a:spcBef>
          <a:spcPct val="20000"/>
        </a:spcBef>
        <a:buFont typeface="Arial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99881" indent="-199986" algn="l" defTabSz="799947" rtl="0" eaLnBrk="1" latinLnBrk="0" hangingPunct="1">
        <a:spcBef>
          <a:spcPct val="20000"/>
        </a:spcBef>
        <a:buFont typeface="Arial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99855" indent="-199986" algn="l" defTabSz="799947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9828" indent="-199986" algn="l" defTabSz="799947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99802" indent="-199986" algn="l" defTabSz="799947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99775" indent="-199986" algn="l" defTabSz="799947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399974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99947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921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99894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99867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99842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99815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99788" algn="l" defTabSz="79994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665631" y="6588224"/>
            <a:ext cx="5742638" cy="1742769"/>
          </a:xfrm>
          <a:prstGeom prst="rect">
            <a:avLst/>
          </a:prstGeom>
          <a:noFill/>
        </p:spPr>
        <p:txBody>
          <a:bodyPr wrap="square" lIns="79995" tIns="39997" rIns="79995" bIns="39997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7. </a:t>
            </a:r>
            <a:r>
              <a:rPr lang="en-US" sz="1200" b="1" i="1" dirty="0">
                <a:solidFill>
                  <a:srgbClr val="000000"/>
                </a:solidFill>
                <a:latin typeface="Arial"/>
                <a:cs typeface="Arial"/>
              </a:rPr>
              <a:t>SlSERK3A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and </a:t>
            </a:r>
            <a:r>
              <a:rPr lang="en-US" sz="1200" b="1" i="1" dirty="0">
                <a:solidFill>
                  <a:srgbClr val="000000"/>
                </a:solidFill>
                <a:latin typeface="Arial"/>
                <a:cs typeface="Arial"/>
              </a:rPr>
              <a:t>SlSER3B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 transcript </a:t>
            </a:r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levels and weight in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silenced </a:t>
            </a:r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roots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.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 (A) </a:t>
            </a:r>
            <a:r>
              <a:rPr lang="en-US" sz="1200" dirty="0" smtClean="0">
                <a:latin typeface="Arial"/>
                <a:cs typeface="Arial"/>
              </a:rPr>
              <a:t>Transcript </a:t>
            </a:r>
            <a:r>
              <a:rPr lang="en-US" sz="1200" dirty="0">
                <a:latin typeface="Arial"/>
                <a:cs typeface="Arial"/>
              </a:rPr>
              <a:t>levels of VIGS-silenced genes were evaluated using </a:t>
            </a:r>
            <a:r>
              <a:rPr lang="en-US" sz="1200" dirty="0" err="1">
                <a:latin typeface="Arial"/>
                <a:cs typeface="Arial"/>
              </a:rPr>
              <a:t>qRT</a:t>
            </a:r>
            <a:r>
              <a:rPr lang="en-US" sz="1200" dirty="0">
                <a:latin typeface="Arial"/>
                <a:cs typeface="Arial"/>
              </a:rPr>
              <a:t>-PCR. Tomato cv. Moneymaker plants treated with TRV empty vector (TRV), TRV-</a:t>
            </a:r>
            <a:r>
              <a:rPr lang="en-US" sz="1200" i="1" dirty="0">
                <a:latin typeface="Arial"/>
                <a:cs typeface="Arial"/>
              </a:rPr>
              <a:t>SlSERK3A, </a:t>
            </a:r>
            <a:r>
              <a:rPr lang="en-US" sz="1200" dirty="0">
                <a:latin typeface="Arial"/>
                <a:cs typeface="Arial"/>
              </a:rPr>
              <a:t>TRV-</a:t>
            </a:r>
            <a:r>
              <a:rPr lang="en-US" sz="1200" i="1" dirty="0">
                <a:latin typeface="Arial"/>
                <a:cs typeface="Arial"/>
              </a:rPr>
              <a:t>SlSERK3B </a:t>
            </a:r>
            <a:r>
              <a:rPr lang="en-US" sz="1200" dirty="0">
                <a:latin typeface="Arial"/>
                <a:cs typeface="Arial"/>
              </a:rPr>
              <a:t>were evaluated</a:t>
            </a:r>
            <a:r>
              <a:rPr lang="en-US" sz="1200" i="1" dirty="0">
                <a:latin typeface="Arial"/>
                <a:cs typeface="Arial"/>
              </a:rPr>
              <a:t>. </a:t>
            </a:r>
            <a:r>
              <a:rPr lang="en-US" sz="1200" dirty="0">
                <a:latin typeface="Arial"/>
                <a:cs typeface="Arial"/>
              </a:rPr>
              <a:t>Expression was normalized against </a:t>
            </a:r>
            <a:r>
              <a:rPr lang="en-US" sz="1200" i="1" dirty="0">
                <a:latin typeface="Arial"/>
                <a:cs typeface="Arial"/>
              </a:rPr>
              <a:t>UBI3. </a:t>
            </a:r>
            <a:r>
              <a:rPr lang="en-US" sz="1200" dirty="0">
                <a:latin typeface="Arial"/>
                <a:cs typeface="Arial"/>
              </a:rPr>
              <a:t>A subsample from </a:t>
            </a:r>
            <a:r>
              <a:rPr lang="en-US" sz="1200" dirty="0" smtClean="0">
                <a:latin typeface="Arial"/>
                <a:cs typeface="Arial"/>
              </a:rPr>
              <a:t>six </a:t>
            </a:r>
            <a:r>
              <a:rPr lang="en-US" sz="1200" dirty="0">
                <a:latin typeface="Arial"/>
                <a:cs typeface="Arial"/>
              </a:rPr>
              <a:t>different </a:t>
            </a:r>
            <a:r>
              <a:rPr lang="en-US" sz="1200">
                <a:latin typeface="Arial"/>
                <a:cs typeface="Arial"/>
              </a:rPr>
              <a:t>roots </a:t>
            </a:r>
            <a:r>
              <a:rPr lang="en-US" sz="1200" smtClean="0">
                <a:latin typeface="Arial"/>
                <a:cs typeface="Arial"/>
              </a:rPr>
              <a:t>was </a:t>
            </a:r>
            <a:r>
              <a:rPr lang="en-US" sz="1200" dirty="0">
                <a:latin typeface="Arial"/>
                <a:cs typeface="Arial"/>
              </a:rPr>
              <a:t>analyzed per construct. Values are average </a:t>
            </a:r>
            <a:r>
              <a:rPr lang="en-US" sz="1200" u="sng" dirty="0">
                <a:latin typeface="Arial"/>
                <a:cs typeface="Arial"/>
              </a:rPr>
              <a:t>+</a:t>
            </a:r>
            <a:r>
              <a:rPr lang="en-US" sz="1200" dirty="0">
                <a:latin typeface="Arial"/>
                <a:cs typeface="Arial"/>
              </a:rPr>
              <a:t> SE of three technical replicates. *</a:t>
            </a:r>
            <a:r>
              <a:rPr lang="en-US" sz="1200" i="1" dirty="0">
                <a:latin typeface="Arial"/>
                <a:cs typeface="Arial"/>
              </a:rPr>
              <a:t>P </a:t>
            </a:r>
            <a:r>
              <a:rPr lang="en-US" sz="1200" dirty="0">
                <a:latin typeface="Arial"/>
                <a:cs typeface="Arial"/>
              </a:rPr>
              <a:t>&lt; 0.05 significant difference from TRV (two-sample </a:t>
            </a:r>
            <a:r>
              <a:rPr lang="en-US" sz="1200" i="1" dirty="0">
                <a:latin typeface="Arial"/>
                <a:cs typeface="Arial"/>
              </a:rPr>
              <a:t>t</a:t>
            </a:r>
            <a:r>
              <a:rPr lang="en-US" sz="1200" dirty="0">
                <a:latin typeface="Arial"/>
                <a:cs typeface="Arial"/>
              </a:rPr>
              <a:t>-test)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. (B) 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Root weight of RKN infected plants. Results are average (±) SE (n=9) shows no significance difference (ANOVA </a:t>
            </a:r>
            <a:r>
              <a:rPr lang="en-US" sz="1200" dirty="0" err="1">
                <a:solidFill>
                  <a:srgbClr val="000000"/>
                </a:solidFill>
                <a:latin typeface="Arial"/>
                <a:cs typeface="Arial"/>
              </a:rPr>
              <a:t>Tukey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 HD test).This experiment was repeated once with similar results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836712" y="179512"/>
            <a:ext cx="5260776" cy="6195813"/>
            <a:chOff x="836712" y="179512"/>
            <a:chExt cx="5260776" cy="6195813"/>
          </a:xfrm>
        </p:grpSpPr>
        <p:graphicFrame>
          <p:nvGraphicFramePr>
            <p:cNvPr id="35" name="Chart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6675955"/>
                </p:ext>
              </p:extLst>
            </p:nvPr>
          </p:nvGraphicFramePr>
          <p:xfrm>
            <a:off x="1628800" y="3278981"/>
            <a:ext cx="331216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6" name="Rectangle 35"/>
            <p:cNvSpPr/>
            <p:nvPr/>
          </p:nvSpPr>
          <p:spPr>
            <a:xfrm>
              <a:off x="2204864" y="5655245"/>
              <a:ext cx="2736304" cy="720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graphicFrame>
          <p:nvGraphicFramePr>
            <p:cNvPr id="42" name="Chart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59225201"/>
                </p:ext>
              </p:extLst>
            </p:nvPr>
          </p:nvGraphicFramePr>
          <p:xfrm>
            <a:off x="1052736" y="395536"/>
            <a:ext cx="4968552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Rectangle 4"/>
            <p:cNvSpPr/>
            <p:nvPr/>
          </p:nvSpPr>
          <p:spPr>
            <a:xfrm>
              <a:off x="1268760" y="2509168"/>
              <a:ext cx="4752528" cy="936104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8938170">
              <a:off x="1049681" y="2687436"/>
              <a:ext cx="1041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8938170">
              <a:off x="1226129" y="2715252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r>
                <a:rPr lang="en-US" sz="1000" dirty="0" smtClean="0">
                  <a:latin typeface="Arial"/>
                  <a:cs typeface="Arial"/>
                </a:rPr>
                <a:t>-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8938170">
              <a:off x="1552261" y="2715253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r>
                <a:rPr lang="en-US" sz="1000" dirty="0" smtClean="0">
                  <a:latin typeface="Arial"/>
                  <a:cs typeface="Arial"/>
                </a:rPr>
                <a:t>-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8938170">
              <a:off x="1865693" y="2721950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r>
                <a:rPr lang="en-US" sz="1000" dirty="0" smtClean="0">
                  <a:latin typeface="Arial"/>
                  <a:cs typeface="Arial"/>
                </a:rPr>
                <a:t>-3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8938170">
              <a:off x="3130087" y="2721950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r>
                <a:rPr lang="en-US" sz="1000" dirty="0" smtClean="0">
                  <a:latin typeface="Arial"/>
                  <a:cs typeface="Arial"/>
                </a:rPr>
                <a:t>-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8938170">
              <a:off x="3460535" y="2715253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r>
                <a:rPr lang="en-US" sz="1000" dirty="0" smtClean="0">
                  <a:latin typeface="Arial"/>
                  <a:cs typeface="Arial"/>
                </a:rPr>
                <a:t>-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8938170">
              <a:off x="3771809" y="2721602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r>
                <a:rPr lang="en-US" sz="1000" dirty="0" smtClean="0">
                  <a:latin typeface="Arial"/>
                  <a:cs typeface="Arial"/>
                </a:rPr>
                <a:t>-3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028924" y="1848396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8938170">
              <a:off x="4106449" y="2727953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r>
                <a:rPr lang="en-US" sz="1000" dirty="0" smtClean="0">
                  <a:latin typeface="Arial"/>
                  <a:cs typeface="Arial"/>
                </a:rPr>
                <a:t>-4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8938170">
              <a:off x="2187633" y="2726142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r>
                <a:rPr lang="en-US" sz="1000" dirty="0" smtClean="0">
                  <a:latin typeface="Arial"/>
                  <a:cs typeface="Arial"/>
                </a:rPr>
                <a:t>-4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342356" y="1945804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665836" y="1830899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298614" y="1907704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354388" y="1750988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030464" y="2169731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8900000">
              <a:off x="2080547" y="5729758"/>
              <a:ext cx="72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836712" y="307174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 smtClean="0">
                  <a:latin typeface="Arial"/>
                  <a:cs typeface="Arial"/>
                </a:rPr>
                <a:t>B</a:t>
              </a:r>
              <a:endParaRPr lang="en-US" sz="1800" b="1" dirty="0">
                <a:latin typeface="Arial"/>
                <a:cs typeface="Arial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36712" y="17951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b="1" dirty="0" smtClean="0">
                  <a:latin typeface="Arial"/>
                  <a:cs typeface="Arial"/>
                </a:rPr>
                <a:t>A</a:t>
              </a:r>
              <a:endParaRPr lang="en-US" sz="1800" b="1" dirty="0">
                <a:latin typeface="Arial"/>
                <a:cs typeface="Arial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655788" y="1462956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305400" y="1907704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620816" y="1920404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619624" y="2051115"/>
              <a:ext cx="476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 rot="18938170">
              <a:off x="4406122" y="2726142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r>
                <a:rPr lang="en-US" sz="1000" dirty="0" smtClean="0">
                  <a:latin typeface="Arial"/>
                  <a:cs typeface="Arial"/>
                </a:rPr>
                <a:t>-5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 rot="18938170">
              <a:off x="4736322" y="2721950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r>
                <a:rPr lang="en-US" sz="1000" dirty="0" smtClean="0">
                  <a:latin typeface="Arial"/>
                  <a:cs typeface="Arial"/>
                </a:rPr>
                <a:t>-6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 rot="18938170">
              <a:off x="2504322" y="2717758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r>
                <a:rPr lang="en-US" sz="1000" dirty="0" smtClean="0">
                  <a:latin typeface="Arial"/>
                  <a:cs typeface="Arial"/>
                </a:rPr>
                <a:t>-5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 rot="18938170">
              <a:off x="2821822" y="2717758"/>
              <a:ext cx="1229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r>
                <a:rPr lang="en-US" sz="1000" dirty="0" smtClean="0">
                  <a:latin typeface="Arial"/>
                  <a:cs typeface="Arial"/>
                </a:rPr>
                <a:t>-6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8900000">
              <a:off x="3334349" y="5940311"/>
              <a:ext cx="13274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B</a:t>
              </a:r>
              <a:endParaRPr lang="en-US" sz="1000" i="1" dirty="0">
                <a:latin typeface="Arial"/>
                <a:cs typeface="Arial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8900000">
              <a:off x="2453361" y="5931803"/>
              <a:ext cx="13274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TRV-</a:t>
              </a:r>
              <a:r>
                <a:rPr lang="en-US" sz="1000" i="1" dirty="0" smtClean="0">
                  <a:latin typeface="Arial"/>
                  <a:cs typeface="Arial"/>
                </a:rPr>
                <a:t>SlSERK3A</a:t>
              </a:r>
              <a:endParaRPr lang="en-US" sz="1000" i="1" dirty="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230</Words>
  <Application>Microsoft Macintosh PowerPoint</Application>
  <PresentationFormat>Letter Paper (8.5x11 in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佈景主題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HSUANCHIEH PENG</dc:creator>
  <cp:lastModifiedBy>Isgouhi Kaloshian</cp:lastModifiedBy>
  <cp:revision>24</cp:revision>
  <dcterms:created xsi:type="dcterms:W3CDTF">2012-12-04T23:40:04Z</dcterms:created>
  <dcterms:modified xsi:type="dcterms:W3CDTF">2014-01-23T22:37:53Z</dcterms:modified>
</cp:coreProperties>
</file>